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8"/>
  </p:normalViewPr>
  <p:slideViewPr>
    <p:cSldViewPr snapToGrid="0">
      <p:cViewPr varScale="1">
        <p:scale>
          <a:sx n="147" d="100"/>
          <a:sy n="147" d="100"/>
        </p:scale>
        <p:origin x="9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F4D45B-074D-0F0B-B2C0-3882986944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561B22-789A-634B-DC73-7598794698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ED50E7-B6E4-5B7F-40B7-C1E6054E3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DEF146-F7C5-C5AF-CF70-096B2E978D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85E42E-FB1C-5F0E-5337-DF092B7A2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463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E3AC5-6AB2-B5D8-AC1F-9FCCAE4A0F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87A544-4257-AE99-9F19-D576430AA9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4AB966-63E3-C6A0-3A0A-501BD6F2C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F1AB8-D297-243F-3042-E4504013E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5E8800E-3B24-E8ED-0CCC-DEB4AB9FE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3644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093BB5-F0DD-2441-BB71-18135B730E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8A77E7-B860-9039-5FF2-B807D23E66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F4D9EF-DFA5-C45E-670A-A077590657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3F89EA-8285-15BD-E302-C9FAD26A4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FC755C-9103-B0DC-EF37-5B0E29B80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912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D314E-9CD8-DC78-4B05-F88BAF3E1A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3DB527-77DB-F129-F54A-921BF682A88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08828F-22AF-A48E-655C-9923751669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EF2973-06EA-EE52-F46A-9188A8B558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CD653B-3DE6-EA05-8D44-8A7187885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9640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32B60-2219-5DA2-9214-60FC590D0F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B62916-4DFE-1901-F328-910926B00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6B2269-4B24-3064-A3B4-4BFB5584C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9BD532-4DA4-8107-4D94-144E2D2B8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BE2F43-71B0-52FD-784D-AF8B591EAE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74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5CCD5-947E-905D-D03B-29992D468E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ABA445-8598-BB8E-2D38-571BCC4E12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39A73AF-B40A-3257-82D9-4E85FF7EBD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9F363B-1529-7B98-F87D-2BDA550769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C8A8AA-5295-78AE-A692-1987D805B9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58F0D3-1313-EDDB-020A-C043CDC2D9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426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31749C-31DD-41DB-8FC1-B6D1EF83E5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BCF391-99CF-132B-BEEE-80CB678020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FE7146D-4F09-E181-493F-2D59A1FC14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3F4AC5-A01A-D2C6-0E8E-16A0EBB7DCA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660A66-3F85-DB27-EA17-38BDC5498A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3002532-B510-620C-020D-411F5CA9E4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9713E7-A6E7-251C-F7CD-884C44EA1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0F3DF19-23C6-9274-239F-CC0897A45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76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505422-B88C-3A1D-1235-8DFF7244B8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88E73C6-623F-E4AA-0F45-33E2A546B9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79938E-DC5A-2CFF-0841-D1004B7E5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E2FF3CB-1EB8-CC03-AFFF-75015DC23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935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32A81A-8BD0-49A9-EB01-BEACD2D00E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DA5537-9E25-4543-3023-B34CD42093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529ACDB-F9D1-678B-AA24-217DC94961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33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0CE23-AEF6-33F4-8A34-9C1008AD0F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B1A998-3816-0E01-04F9-2F2255C463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B2FAEA3-EC55-7AC5-584E-2DD4FACE8C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69A9E1-D45F-F640-D8A3-60102C9692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52AE66-E5F9-1E00-AE69-A7B2E229D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8C75E52-B32C-A094-EAEA-0D4A1DB8EA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35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A4DC2-39E8-09DA-5AD8-A2C9357274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C2530B-4B37-97C4-F609-0F669B23A9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CBB3D-E384-80D7-3A4D-1F0410A348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C1A035-CD92-A4B4-2E50-F49C7A22B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3756F1-9FCB-F1C4-AAA7-80EDB8C0C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4CD2F-B21D-FA12-9CC8-054A39257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860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32FD73-7377-C3FD-FBBF-480C1E6D3E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B90931-2163-D9A4-2022-F3D9B573BD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99B98-5341-24C7-007C-4AF015701D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939B63-F582-7A46-BFFB-6B3BE2B2EDF6}" type="datetimeFigureOut">
              <a:rPr lang="en-US" smtClean="0"/>
              <a:t>7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B511B8-0745-2FA5-A398-2C52373F16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8F5369-EF9C-9B89-D2DD-0D2461C5156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FE6B8A5-8258-1C41-98EF-31958E95AC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6381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D6EC134-8F03-90E7-430C-6E6D2269F7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2214" y="3871082"/>
            <a:ext cx="1803400" cy="177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6E6F6C8-CC66-3113-CD94-A9421D7A053D}"/>
              </a:ext>
            </a:extLst>
          </p:cNvPr>
          <p:cNvSpPr txBox="1"/>
          <p:nvPr/>
        </p:nvSpPr>
        <p:spPr>
          <a:xfrm>
            <a:off x="3255614" y="5245874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sotyp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5121856-7D7B-BCFD-B2F6-F7A46029D7CF}"/>
              </a:ext>
            </a:extLst>
          </p:cNvPr>
          <p:cNvSpPr txBox="1"/>
          <p:nvPr/>
        </p:nvSpPr>
        <p:spPr>
          <a:xfrm>
            <a:off x="3255613" y="4748992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U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1090C3-08E5-5988-09CD-5B07DFC31502}"/>
              </a:ext>
            </a:extLst>
          </p:cNvPr>
          <p:cNvSpPr txBox="1"/>
          <p:nvPr/>
        </p:nvSpPr>
        <p:spPr>
          <a:xfrm>
            <a:off x="3211132" y="4186927"/>
            <a:ext cx="1088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g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C1FB1A-DDAD-E816-CA3F-A68495B03910}"/>
              </a:ext>
            </a:extLst>
          </p:cNvPr>
          <p:cNvSpPr txBox="1"/>
          <p:nvPr/>
        </p:nvSpPr>
        <p:spPr>
          <a:xfrm>
            <a:off x="2447781" y="5245874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F012DC-3F90-A8DF-9F93-180CC830EB71}"/>
              </a:ext>
            </a:extLst>
          </p:cNvPr>
          <p:cNvSpPr txBox="1"/>
          <p:nvPr/>
        </p:nvSpPr>
        <p:spPr>
          <a:xfrm>
            <a:off x="1578632" y="4716401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282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7F27DEF-7E25-03DC-9CAA-30612F51C080}"/>
              </a:ext>
            </a:extLst>
          </p:cNvPr>
          <p:cNvSpPr txBox="1"/>
          <p:nvPr/>
        </p:nvSpPr>
        <p:spPr>
          <a:xfrm>
            <a:off x="1578632" y="4170631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684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6A5EAC5E-7BD2-4201-EB2B-32529B3EE3C2}"/>
              </a:ext>
            </a:extLst>
          </p:cNvPr>
          <p:cNvCxnSpPr/>
          <p:nvPr/>
        </p:nvCxnSpPr>
        <p:spPr>
          <a:xfrm>
            <a:off x="1701210" y="5794744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9873DE72-475B-C475-6755-F00199215CAF}"/>
              </a:ext>
            </a:extLst>
          </p:cNvPr>
          <p:cNvSpPr txBox="1"/>
          <p:nvPr/>
        </p:nvSpPr>
        <p:spPr>
          <a:xfrm>
            <a:off x="2447781" y="565352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CE09825-64DC-10F0-7739-CB5A26F57E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13596" y="3929520"/>
            <a:ext cx="1803400" cy="17780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D58D43C-0C7F-683E-38F9-CC5B91215895}"/>
              </a:ext>
            </a:extLst>
          </p:cNvPr>
          <p:cNvSpPr txBox="1"/>
          <p:nvPr/>
        </p:nvSpPr>
        <p:spPr>
          <a:xfrm>
            <a:off x="6650956" y="5291944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sotyp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413A5A8-6C25-7F6F-35AB-CEDA6F34D990}"/>
              </a:ext>
            </a:extLst>
          </p:cNvPr>
          <p:cNvSpPr txBox="1"/>
          <p:nvPr/>
        </p:nvSpPr>
        <p:spPr>
          <a:xfrm>
            <a:off x="6650955" y="4795062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U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EC034E0-10C3-349A-DE0D-237A46319445}"/>
              </a:ext>
            </a:extLst>
          </p:cNvPr>
          <p:cNvSpPr txBox="1"/>
          <p:nvPr/>
        </p:nvSpPr>
        <p:spPr>
          <a:xfrm>
            <a:off x="6606474" y="4232997"/>
            <a:ext cx="1088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gM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BDD8A3C-BB53-F22F-D13E-52E8BD04BFBD}"/>
              </a:ext>
            </a:extLst>
          </p:cNvPr>
          <p:cNvSpPr txBox="1"/>
          <p:nvPr/>
        </p:nvSpPr>
        <p:spPr>
          <a:xfrm>
            <a:off x="5843123" y="5291944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EB6E3C7-E5FB-FDFD-9C9B-0CAC007662A4}"/>
              </a:ext>
            </a:extLst>
          </p:cNvPr>
          <p:cNvSpPr txBox="1"/>
          <p:nvPr/>
        </p:nvSpPr>
        <p:spPr>
          <a:xfrm>
            <a:off x="4973974" y="4762471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318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F9C629-2539-4236-0822-F7DAA8A74610}"/>
              </a:ext>
            </a:extLst>
          </p:cNvPr>
          <p:cNvSpPr txBox="1"/>
          <p:nvPr/>
        </p:nvSpPr>
        <p:spPr>
          <a:xfrm>
            <a:off x="4973974" y="4216701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108</a:t>
            </a:r>
          </a:p>
        </p:txBody>
      </p: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B6305471-14C4-64ED-D937-60C220CB88C5}"/>
              </a:ext>
            </a:extLst>
          </p:cNvPr>
          <p:cNvCxnSpPr/>
          <p:nvPr/>
        </p:nvCxnSpPr>
        <p:spPr>
          <a:xfrm>
            <a:off x="5096552" y="5840814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979A98C-F945-82B1-1EEA-021FB908406F}"/>
              </a:ext>
            </a:extLst>
          </p:cNvPr>
          <p:cNvSpPr txBox="1"/>
          <p:nvPr/>
        </p:nvSpPr>
        <p:spPr>
          <a:xfrm>
            <a:off x="5843123" y="569959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9792B7B5-2875-7EFE-28FC-EF0EA51796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937501" y="3929520"/>
            <a:ext cx="1803400" cy="1778000"/>
          </a:xfrm>
          <a:prstGeom prst="rect">
            <a:avLst/>
          </a:prstGeom>
        </p:spPr>
      </p:pic>
      <p:sp>
        <p:nvSpPr>
          <p:cNvPr id="45" name="TextBox 44">
            <a:extLst>
              <a:ext uri="{FF2B5EF4-FFF2-40B4-BE49-F238E27FC236}">
                <a16:creationId xmlns:a16="http://schemas.microsoft.com/office/drawing/2014/main" id="{23CCA2FB-565E-919F-962A-7C4834256B33}"/>
              </a:ext>
            </a:extLst>
          </p:cNvPr>
          <p:cNvSpPr txBox="1"/>
          <p:nvPr/>
        </p:nvSpPr>
        <p:spPr>
          <a:xfrm>
            <a:off x="9748579" y="5327385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sotype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B205EDD-BD49-CCC0-2CB5-743B68AE0CF4}"/>
              </a:ext>
            </a:extLst>
          </p:cNvPr>
          <p:cNvSpPr txBox="1"/>
          <p:nvPr/>
        </p:nvSpPr>
        <p:spPr>
          <a:xfrm>
            <a:off x="9748578" y="4830503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UT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66FD0D4-A445-73E9-50D8-BA5DEB0B833D}"/>
              </a:ext>
            </a:extLst>
          </p:cNvPr>
          <p:cNvSpPr txBox="1"/>
          <p:nvPr/>
        </p:nvSpPr>
        <p:spPr>
          <a:xfrm>
            <a:off x="9704097" y="4268438"/>
            <a:ext cx="1088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gM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470F1AB-4E89-FA62-AEE3-19C42CF095EF}"/>
              </a:ext>
            </a:extLst>
          </p:cNvPr>
          <p:cNvSpPr txBox="1"/>
          <p:nvPr/>
        </p:nvSpPr>
        <p:spPr>
          <a:xfrm>
            <a:off x="8940746" y="5327385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11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690EA6E-5547-0765-F698-71F0D637FD9A}"/>
              </a:ext>
            </a:extLst>
          </p:cNvPr>
          <p:cNvSpPr txBox="1"/>
          <p:nvPr/>
        </p:nvSpPr>
        <p:spPr>
          <a:xfrm>
            <a:off x="8071597" y="4797912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334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B26FD5D-18B8-7774-94EF-AED9724D5976}"/>
              </a:ext>
            </a:extLst>
          </p:cNvPr>
          <p:cNvSpPr txBox="1"/>
          <p:nvPr/>
        </p:nvSpPr>
        <p:spPr>
          <a:xfrm>
            <a:off x="8071597" y="4252142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9705</a:t>
            </a: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AB2B2638-9B00-1952-39DB-85B1B4EA0A2A}"/>
              </a:ext>
            </a:extLst>
          </p:cNvPr>
          <p:cNvCxnSpPr/>
          <p:nvPr/>
        </p:nvCxnSpPr>
        <p:spPr>
          <a:xfrm>
            <a:off x="8194175" y="5876255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A029CEDE-3EBF-B1A6-D1D2-7C70DD9E233B}"/>
              </a:ext>
            </a:extLst>
          </p:cNvPr>
          <p:cNvSpPr txBox="1"/>
          <p:nvPr/>
        </p:nvSpPr>
        <p:spPr>
          <a:xfrm>
            <a:off x="8940746" y="573503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69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id="{38354CF8-5728-031E-C3D0-67059BDB2DC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20180" y="927479"/>
            <a:ext cx="1803400" cy="1778000"/>
          </a:xfrm>
          <a:prstGeom prst="rect">
            <a:avLst/>
          </a:prstGeom>
        </p:spPr>
      </p:pic>
      <p:sp>
        <p:nvSpPr>
          <p:cNvPr id="54" name="TextBox 53">
            <a:extLst>
              <a:ext uri="{FF2B5EF4-FFF2-40B4-BE49-F238E27FC236}">
                <a16:creationId xmlns:a16="http://schemas.microsoft.com/office/drawing/2014/main" id="{2209B7B0-9620-A0B6-1AA9-1A0A86108F18}"/>
              </a:ext>
            </a:extLst>
          </p:cNvPr>
          <p:cNvSpPr txBox="1"/>
          <p:nvPr/>
        </p:nvSpPr>
        <p:spPr>
          <a:xfrm>
            <a:off x="3057134" y="2293562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sotyp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7D82845-6E8A-564E-842F-9A6AC2A62772}"/>
              </a:ext>
            </a:extLst>
          </p:cNvPr>
          <p:cNvSpPr txBox="1"/>
          <p:nvPr/>
        </p:nvSpPr>
        <p:spPr>
          <a:xfrm>
            <a:off x="3057133" y="1796680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U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5E37B71F-34B5-9323-9AFD-9FA3EDC811C6}"/>
              </a:ext>
            </a:extLst>
          </p:cNvPr>
          <p:cNvSpPr txBox="1"/>
          <p:nvPr/>
        </p:nvSpPr>
        <p:spPr>
          <a:xfrm>
            <a:off x="3012652" y="1234615"/>
            <a:ext cx="1059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gM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C7FBADD-7240-0650-DD09-9EB5F1FA2BF0}"/>
              </a:ext>
            </a:extLst>
          </p:cNvPr>
          <p:cNvSpPr txBox="1"/>
          <p:nvPr/>
        </p:nvSpPr>
        <p:spPr>
          <a:xfrm>
            <a:off x="2249301" y="2293562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144BE97-852B-DFB1-4E62-9E4BB808C795}"/>
              </a:ext>
            </a:extLst>
          </p:cNvPr>
          <p:cNvSpPr txBox="1"/>
          <p:nvPr/>
        </p:nvSpPr>
        <p:spPr>
          <a:xfrm>
            <a:off x="1380152" y="1764089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616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E48AE97-D851-0CBD-E61C-3CC442FD516D}"/>
              </a:ext>
            </a:extLst>
          </p:cNvPr>
          <p:cNvSpPr txBox="1"/>
          <p:nvPr/>
        </p:nvSpPr>
        <p:spPr>
          <a:xfrm>
            <a:off x="1380152" y="1218319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7170</a:t>
            </a:r>
          </a:p>
        </p:txBody>
      </p: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10D184B1-4AE6-F377-E64A-9475720F2BFB}"/>
              </a:ext>
            </a:extLst>
          </p:cNvPr>
          <p:cNvCxnSpPr/>
          <p:nvPr/>
        </p:nvCxnSpPr>
        <p:spPr>
          <a:xfrm>
            <a:off x="1502730" y="2842432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6377468B-507F-2809-1976-D855C4E82DC5}"/>
              </a:ext>
            </a:extLst>
          </p:cNvPr>
          <p:cNvSpPr txBox="1"/>
          <p:nvPr/>
        </p:nvSpPr>
        <p:spPr>
          <a:xfrm>
            <a:off x="2249301" y="2701210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7</a:t>
            </a:r>
          </a:p>
        </p:txBody>
      </p:sp>
      <p:pic>
        <p:nvPicPr>
          <p:cNvPr id="62" name="Picture 61">
            <a:extLst>
              <a:ext uri="{FF2B5EF4-FFF2-40B4-BE49-F238E27FC236}">
                <a16:creationId xmlns:a16="http://schemas.microsoft.com/office/drawing/2014/main" id="{2E2820C7-D5A8-7C36-08B8-5A069310F5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75677" y="931919"/>
            <a:ext cx="1803400" cy="1778000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F88A22CC-36B8-4AC8-E75F-459116AB641C}"/>
              </a:ext>
            </a:extLst>
          </p:cNvPr>
          <p:cNvSpPr txBox="1"/>
          <p:nvPr/>
        </p:nvSpPr>
        <p:spPr>
          <a:xfrm>
            <a:off x="6580065" y="2286469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sotyp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1E2B60C-7E86-2B75-70C7-751BE6AC0F6E}"/>
              </a:ext>
            </a:extLst>
          </p:cNvPr>
          <p:cNvSpPr txBox="1"/>
          <p:nvPr/>
        </p:nvSpPr>
        <p:spPr>
          <a:xfrm>
            <a:off x="6580064" y="1789587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UT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4B88B5A8-3DA4-A49A-FCCF-1362BE277159}"/>
              </a:ext>
            </a:extLst>
          </p:cNvPr>
          <p:cNvSpPr txBox="1"/>
          <p:nvPr/>
        </p:nvSpPr>
        <p:spPr>
          <a:xfrm>
            <a:off x="6535583" y="1227522"/>
            <a:ext cx="1088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gM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1718631-7E8A-D1CC-6824-9DB167A24364}"/>
              </a:ext>
            </a:extLst>
          </p:cNvPr>
          <p:cNvSpPr txBox="1"/>
          <p:nvPr/>
        </p:nvSpPr>
        <p:spPr>
          <a:xfrm>
            <a:off x="5772232" y="2286469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9E90F58-3ED4-EDFB-3FDE-2FE919207B05}"/>
              </a:ext>
            </a:extLst>
          </p:cNvPr>
          <p:cNvSpPr txBox="1"/>
          <p:nvPr/>
        </p:nvSpPr>
        <p:spPr>
          <a:xfrm>
            <a:off x="4903083" y="1756996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7105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0CCB176A-1B5C-3C36-5613-07C111E029C0}"/>
              </a:ext>
            </a:extLst>
          </p:cNvPr>
          <p:cNvSpPr txBox="1"/>
          <p:nvPr/>
        </p:nvSpPr>
        <p:spPr>
          <a:xfrm>
            <a:off x="4903083" y="1211226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870</a:t>
            </a:r>
          </a:p>
        </p:txBody>
      </p: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ECF9BA15-E55B-07F3-582A-F166D85EDA45}"/>
              </a:ext>
            </a:extLst>
          </p:cNvPr>
          <p:cNvCxnSpPr/>
          <p:nvPr/>
        </p:nvCxnSpPr>
        <p:spPr>
          <a:xfrm>
            <a:off x="5025661" y="2835339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6DD161B0-CFF0-170B-C3C6-B3AB235EF6F3}"/>
              </a:ext>
            </a:extLst>
          </p:cNvPr>
          <p:cNvSpPr txBox="1"/>
          <p:nvPr/>
        </p:nvSpPr>
        <p:spPr>
          <a:xfrm>
            <a:off x="5772232" y="2694117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7</a:t>
            </a:r>
          </a:p>
        </p:txBody>
      </p:sp>
      <p:pic>
        <p:nvPicPr>
          <p:cNvPr id="71" name="Picture 70">
            <a:extLst>
              <a:ext uri="{FF2B5EF4-FFF2-40B4-BE49-F238E27FC236}">
                <a16:creationId xmlns:a16="http://schemas.microsoft.com/office/drawing/2014/main" id="{FCDF33A0-C2F3-B2B1-DC6E-C6BEEEA48E9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033818" y="923210"/>
            <a:ext cx="1803400" cy="1778000"/>
          </a:xfrm>
          <a:prstGeom prst="rect">
            <a:avLst/>
          </a:prstGeom>
        </p:spPr>
      </p:pic>
      <p:sp>
        <p:nvSpPr>
          <p:cNvPr id="72" name="TextBox 71">
            <a:extLst>
              <a:ext uri="{FF2B5EF4-FFF2-40B4-BE49-F238E27FC236}">
                <a16:creationId xmlns:a16="http://schemas.microsoft.com/office/drawing/2014/main" id="{BA559474-DCC2-65A7-A4BA-D2385CDF233E}"/>
              </a:ext>
            </a:extLst>
          </p:cNvPr>
          <p:cNvSpPr txBox="1"/>
          <p:nvPr/>
        </p:nvSpPr>
        <p:spPr>
          <a:xfrm>
            <a:off x="9869080" y="2311275"/>
            <a:ext cx="12859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sotype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0306F780-AE2B-DD1A-5715-2594CCB40C09}"/>
              </a:ext>
            </a:extLst>
          </p:cNvPr>
          <p:cNvSpPr txBox="1"/>
          <p:nvPr/>
        </p:nvSpPr>
        <p:spPr>
          <a:xfrm>
            <a:off x="9869079" y="1814393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U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59AC7CF-0DE8-7E52-5A40-315798BE178F}"/>
              </a:ext>
            </a:extLst>
          </p:cNvPr>
          <p:cNvSpPr txBox="1"/>
          <p:nvPr/>
        </p:nvSpPr>
        <p:spPr>
          <a:xfrm>
            <a:off x="9824598" y="1252328"/>
            <a:ext cx="10887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JAB-Cells-IgM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2048375-02EF-F8CB-7EDC-667254D35B01}"/>
              </a:ext>
            </a:extLst>
          </p:cNvPr>
          <p:cNvSpPr txBox="1"/>
          <p:nvPr/>
        </p:nvSpPr>
        <p:spPr>
          <a:xfrm>
            <a:off x="9061247" y="2311275"/>
            <a:ext cx="6928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F7342DC-CF8E-FE4E-742A-D71DDDF9E287}"/>
              </a:ext>
            </a:extLst>
          </p:cNvPr>
          <p:cNvSpPr txBox="1"/>
          <p:nvPr/>
        </p:nvSpPr>
        <p:spPr>
          <a:xfrm>
            <a:off x="8192098" y="1781802"/>
            <a:ext cx="8691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 710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D6C354C-E913-6C77-9488-10272E42C90E}"/>
              </a:ext>
            </a:extLst>
          </p:cNvPr>
          <p:cNvSpPr txBox="1"/>
          <p:nvPr/>
        </p:nvSpPr>
        <p:spPr>
          <a:xfrm>
            <a:off x="8192098" y="1236032"/>
            <a:ext cx="8338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FI = 6824</a:t>
            </a:r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C0923203-BD19-3FA6-16C0-D994D3914DCC}"/>
              </a:ext>
            </a:extLst>
          </p:cNvPr>
          <p:cNvCxnSpPr/>
          <p:nvPr/>
        </p:nvCxnSpPr>
        <p:spPr>
          <a:xfrm>
            <a:off x="8314676" y="2860145"/>
            <a:ext cx="746571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B97CC588-68FE-14EF-ED75-07B7FB50D7A0}"/>
              </a:ext>
            </a:extLst>
          </p:cNvPr>
          <p:cNvSpPr txBox="1"/>
          <p:nvPr/>
        </p:nvSpPr>
        <p:spPr>
          <a:xfrm>
            <a:off x="9061247" y="2718923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7</a:t>
            </a:r>
          </a:p>
        </p:txBody>
      </p:sp>
    </p:spTree>
    <p:extLst>
      <p:ext uri="{BB962C8B-B14F-4D97-AF65-F5344CB8AC3E}">
        <p14:creationId xmlns:p14="http://schemas.microsoft.com/office/powerpoint/2010/main" val="3703611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B5558FD-B31C-6563-C757-3DE794B350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5326623"/>
              </p:ext>
            </p:extLst>
          </p:nvPr>
        </p:nvGraphicFramePr>
        <p:xfrm>
          <a:off x="805562" y="954757"/>
          <a:ext cx="3829050" cy="4225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29683" imgH="4226593" progId="Prism10.Document">
                  <p:embed/>
                </p:oleObj>
              </mc:Choice>
              <mc:Fallback>
                <p:oleObj name="Prism 10" r:id="rId2" imgW="3829683" imgH="422659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05562" y="954757"/>
                        <a:ext cx="3829050" cy="4225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101C9B92-0156-E80D-B61D-E3A5535F2B4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5202630"/>
              </p:ext>
            </p:extLst>
          </p:nvPr>
        </p:nvGraphicFramePr>
        <p:xfrm>
          <a:off x="6002083" y="1216741"/>
          <a:ext cx="3913187" cy="3797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913595" imgH="3796697" progId="Prism10.Document">
                  <p:embed/>
                </p:oleObj>
              </mc:Choice>
              <mc:Fallback>
                <p:oleObj name="Prism 10" r:id="rId4" imgW="3913595" imgH="3796697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02083" y="1216741"/>
                        <a:ext cx="3913187" cy="3797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47566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78</Words>
  <Application>Microsoft Office PowerPoint</Application>
  <PresentationFormat>Widescreen</PresentationFormat>
  <Paragraphs>42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GraphPad Prism Projec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ngh, Satya (NIH/NIAID) [E]</dc:creator>
  <cp:lastModifiedBy>Kaur, Sukhbir (NIH/NCI) [E]</cp:lastModifiedBy>
  <cp:revision>9</cp:revision>
  <dcterms:created xsi:type="dcterms:W3CDTF">2025-07-21T19:24:00Z</dcterms:created>
  <dcterms:modified xsi:type="dcterms:W3CDTF">2025-07-23T12:26:05Z</dcterms:modified>
</cp:coreProperties>
</file>